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7" d="100"/>
          <a:sy n="57" d="100"/>
        </p:scale>
        <p:origin x="259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623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421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632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487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43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416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863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865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842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221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80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A0A94-4811-4E3E-AF34-839606DC294C}" type="datetimeFigureOut">
              <a:rPr lang="en-US" smtClean="0"/>
              <a:t>9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BC313-BD4A-4102-B037-878E92654D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832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13" Type="http://schemas.openxmlformats.org/officeDocument/2006/relationships/image" Target="../media/image25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12" Type="http://schemas.microsoft.com/office/2007/relationships/hdphoto" Target="../media/hdphoto1.wdp"/><Relationship Id="rId2" Type="http://schemas.openxmlformats.org/officeDocument/2006/relationships/image" Target="../media/image15.jpeg"/><Relationship Id="rId16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4.png"/><Relationship Id="rId5" Type="http://schemas.openxmlformats.org/officeDocument/2006/relationships/image" Target="../media/image18.jpeg"/><Relationship Id="rId15" Type="http://schemas.openxmlformats.org/officeDocument/2006/relationships/image" Target="../media/image27.jpeg"/><Relationship Id="rId10" Type="http://schemas.openxmlformats.org/officeDocument/2006/relationships/image" Target="../media/image23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Relationship Id="rId14" Type="http://schemas.openxmlformats.org/officeDocument/2006/relationships/image" Target="../media/image2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176" y="140762"/>
            <a:ext cx="6914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</a:t>
            </a:r>
            <a:r>
              <a:rPr lang="en-US" sz="1400" b="1" dirty="0" smtClean="0"/>
              <a:t>4A: Raw western blots and their respective images superimposed with membrane.</a:t>
            </a:r>
            <a:endParaRPr lang="en-US" sz="1400" b="1" dirty="0"/>
          </a:p>
        </p:txBody>
      </p:sp>
      <p:grpSp>
        <p:nvGrpSpPr>
          <p:cNvPr id="66" name="Group 65"/>
          <p:cNvGrpSpPr/>
          <p:nvPr/>
        </p:nvGrpSpPr>
        <p:grpSpPr>
          <a:xfrm>
            <a:off x="29109" y="462651"/>
            <a:ext cx="6638562" cy="9413868"/>
            <a:chOff x="29109" y="462651"/>
            <a:chExt cx="6638562" cy="9413868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20" t="28379" r="19759" b="40077"/>
            <a:stretch/>
          </p:blipFill>
          <p:spPr>
            <a:xfrm>
              <a:off x="3166365" y="8597114"/>
              <a:ext cx="2624835" cy="800886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63" t="24524" r="16533" b="46446"/>
            <a:stretch/>
          </p:blipFill>
          <p:spPr>
            <a:xfrm>
              <a:off x="482275" y="8609669"/>
              <a:ext cx="2382113" cy="694217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41" t="23457" r="12956" b="39542"/>
            <a:stretch/>
          </p:blipFill>
          <p:spPr>
            <a:xfrm>
              <a:off x="3303933" y="7597038"/>
              <a:ext cx="2578100" cy="933778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84" t="29472" r="8935" b="30113"/>
            <a:stretch/>
          </p:blipFill>
          <p:spPr>
            <a:xfrm>
              <a:off x="456875" y="7564091"/>
              <a:ext cx="2445657" cy="954075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58" t="19449" r="9636" b="33788"/>
            <a:stretch/>
          </p:blipFill>
          <p:spPr>
            <a:xfrm>
              <a:off x="3263900" y="6465844"/>
              <a:ext cx="2499474" cy="1044381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25" t="23907" r="13795" b="31125"/>
            <a:stretch/>
          </p:blipFill>
          <p:spPr>
            <a:xfrm>
              <a:off x="433250" y="6466012"/>
              <a:ext cx="2405655" cy="1044213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62" t="34928" r="12730" b="26475"/>
            <a:stretch/>
          </p:blipFill>
          <p:spPr>
            <a:xfrm>
              <a:off x="3291840" y="5407411"/>
              <a:ext cx="2484120" cy="943731"/>
            </a:xfrm>
            <a:prstGeom prst="rect">
              <a:avLst/>
            </a:prstGeom>
          </p:spPr>
        </p:pic>
        <p:pic>
          <p:nvPicPr>
            <p:cNvPr id="55" name="Picture 5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85" t="24637" r="11734" b="36656"/>
            <a:stretch/>
          </p:blipFill>
          <p:spPr>
            <a:xfrm>
              <a:off x="471350" y="5421090"/>
              <a:ext cx="2509183" cy="958565"/>
            </a:xfrm>
            <a:prstGeom prst="rect">
              <a:avLst/>
            </a:prstGeom>
          </p:spPr>
        </p:pic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24" t="37527" r="11698" b="22197"/>
            <a:stretch/>
          </p:blipFill>
          <p:spPr>
            <a:xfrm>
              <a:off x="3192781" y="4444175"/>
              <a:ext cx="2606040" cy="965879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85" t="24151" r="14650" b="40070"/>
            <a:stretch/>
          </p:blipFill>
          <p:spPr>
            <a:xfrm>
              <a:off x="457200" y="4429022"/>
              <a:ext cx="2447188" cy="890251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34" t="17894" r="11029" b="13991"/>
            <a:stretch/>
          </p:blipFill>
          <p:spPr>
            <a:xfrm>
              <a:off x="3251200" y="2823040"/>
              <a:ext cx="2540000" cy="1548928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3" t="18078" r="6913" b="13807"/>
            <a:stretch/>
          </p:blipFill>
          <p:spPr>
            <a:xfrm>
              <a:off x="445771" y="2819400"/>
              <a:ext cx="2619309" cy="1546507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60" t="14881" r="8123" b="18232"/>
            <a:stretch/>
          </p:blipFill>
          <p:spPr>
            <a:xfrm>
              <a:off x="454114" y="1259084"/>
              <a:ext cx="2602693" cy="1517078"/>
            </a:xfrm>
            <a:prstGeom prst="rect">
              <a:avLst/>
            </a:prstGeom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35" r="11764" b="18364"/>
            <a:stretch/>
          </p:blipFill>
          <p:spPr>
            <a:xfrm>
              <a:off x="3157207" y="1259084"/>
              <a:ext cx="2649233" cy="1513879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5824292" y="6548856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pMLC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839553" y="7671768"/>
              <a:ext cx="7580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MLC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760791" y="8713687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GAPDH</a:t>
              </a:r>
            </a:p>
            <a:p>
              <a:r>
                <a:rPr lang="en-US" sz="1400" b="1" dirty="0" smtClean="0"/>
                <a:t>(37kDa)</a:t>
              </a:r>
              <a:endParaRPr lang="en-US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87417" y="9599520"/>
              <a:ext cx="13645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M: Protein Marker</a:t>
              </a:r>
              <a:endParaRPr lang="en-US" sz="1200" b="1" dirty="0"/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1373051" y="1068617"/>
              <a:ext cx="1371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1720658" y="785906"/>
              <a:ext cx="815863" cy="2934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DJ4 (µM)</a:t>
              </a:r>
              <a:endParaRPr lang="en-US" sz="1400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99917" y="1068617"/>
              <a:ext cx="23808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T 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.02  0.04  0.06  0.08   0.1 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756091" y="785906"/>
              <a:ext cx="2028813" cy="861209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3583045" y="785906"/>
              <a:ext cx="2086740" cy="8612094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59154" y="950505"/>
              <a:ext cx="426955" cy="376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M</a:t>
              </a:r>
              <a:endParaRPr lang="en-US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219251" y="950505"/>
              <a:ext cx="426955" cy="3762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M</a:t>
              </a:r>
              <a:endParaRPr lang="en-US" b="1" dirty="0"/>
            </a:p>
          </p:txBody>
        </p:sp>
        <p:cxnSp>
          <p:nvCxnSpPr>
            <p:cNvPr id="46" name="Straight Connector 45"/>
            <p:cNvCxnSpPr/>
            <p:nvPr/>
          </p:nvCxnSpPr>
          <p:spPr>
            <a:xfrm>
              <a:off x="4232676" y="1061618"/>
              <a:ext cx="137160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4580283" y="778907"/>
              <a:ext cx="815863" cy="2934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DJ4 (µM)</a:t>
              </a:r>
              <a:endParaRPr lang="en-US" sz="14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803593" y="5715539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MYPT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40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780957" y="4644749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pMYPT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40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780791" y="3230010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ROCK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61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759707" y="1564780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ROCK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5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175781" y="462651"/>
              <a:ext cx="11737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Actual Blots</a:t>
              </a:r>
              <a:endParaRPr lang="en-US" sz="16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3218" y="498173"/>
              <a:ext cx="28500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Blots-superimposed with membrane</a:t>
              </a:r>
              <a:endParaRPr lang="en-US" sz="1400" dirty="0"/>
            </a:p>
          </p:txBody>
        </p:sp>
        <p:sp>
          <p:nvSpPr>
            <p:cNvPr id="15" name="Right Arrow 14"/>
            <p:cNvSpPr/>
            <p:nvPr/>
          </p:nvSpPr>
          <p:spPr>
            <a:xfrm>
              <a:off x="3436766" y="585329"/>
              <a:ext cx="619425" cy="12397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109" y="1029292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/>
                <a:t>kDa</a:t>
              </a:r>
              <a:endParaRPr lang="en-US" sz="12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7524" y="1506316"/>
              <a:ext cx="420371" cy="1292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endParaRPr lang="en-US" sz="700" b="1" dirty="0"/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1400" b="1" dirty="0"/>
            </a:p>
            <a:p>
              <a:pPr algn="r"/>
              <a:r>
                <a:rPr lang="en-US" sz="1200" b="1" dirty="0" smtClean="0"/>
                <a:t>62</a:t>
              </a:r>
            </a:p>
            <a:p>
              <a:pPr algn="r"/>
              <a:endParaRPr lang="en-US" sz="900" b="1" dirty="0"/>
            </a:p>
            <a:p>
              <a:pPr algn="r"/>
              <a:r>
                <a:rPr lang="en-US" sz="1200" b="1" dirty="0" smtClean="0"/>
                <a:t>49</a:t>
              </a:r>
              <a:endParaRPr lang="en-US" sz="12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7999" y="3167898"/>
              <a:ext cx="420371" cy="12926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endParaRPr lang="en-US" sz="800" b="1" dirty="0"/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1200" b="1" dirty="0"/>
            </a:p>
            <a:p>
              <a:pPr algn="r"/>
              <a:r>
                <a:rPr lang="en-US" sz="1200" b="1" dirty="0" smtClean="0"/>
                <a:t>62</a:t>
              </a:r>
            </a:p>
            <a:p>
              <a:pPr algn="r"/>
              <a:endParaRPr lang="en-US" sz="1000" b="1" dirty="0"/>
            </a:p>
            <a:p>
              <a:pPr algn="r"/>
              <a:r>
                <a:rPr lang="en-US" sz="1200" b="1" dirty="0" smtClean="0"/>
                <a:t>49</a:t>
              </a:r>
              <a:endParaRPr lang="en-US" sz="12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90699" y="4618873"/>
              <a:ext cx="420371" cy="723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400" b="1" dirty="0" smtClean="0"/>
            </a:p>
            <a:p>
              <a:pPr algn="r"/>
              <a:r>
                <a:rPr lang="en-US" sz="1200" b="1" dirty="0" smtClean="0"/>
                <a:t>62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97049" y="5666623"/>
              <a:ext cx="420371" cy="723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400" b="1" dirty="0" smtClean="0"/>
            </a:p>
            <a:p>
              <a:pPr algn="r"/>
              <a:r>
                <a:rPr lang="en-US" sz="1200" b="1" dirty="0" smtClean="0"/>
                <a:t>62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24531" y="7487777"/>
              <a:ext cx="341825" cy="1100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28</a:t>
              </a: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17</a:t>
              </a:r>
            </a:p>
            <a:p>
              <a:pPr algn="r"/>
              <a:r>
                <a:rPr lang="en-US" sz="1200" b="1" dirty="0" smtClean="0"/>
                <a:t>14</a:t>
              </a:r>
            </a:p>
            <a:p>
              <a:pPr algn="r"/>
              <a:endParaRPr lang="en-US" sz="700" b="1" dirty="0" smtClean="0"/>
            </a:p>
            <a:p>
              <a:pPr algn="r"/>
              <a:r>
                <a:rPr lang="en-US" sz="1200" b="1" dirty="0" smtClean="0"/>
                <a:t>6</a:t>
              </a:r>
            </a:p>
            <a:p>
              <a:pPr algn="r"/>
              <a:r>
                <a:rPr lang="en-US" sz="1200" b="1" dirty="0" smtClean="0"/>
                <a:t>3</a:t>
              </a:r>
              <a:endParaRPr lang="en-US" sz="12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3370" y="8660648"/>
              <a:ext cx="341825" cy="684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49</a:t>
              </a:r>
            </a:p>
            <a:p>
              <a:pPr algn="r"/>
              <a:endParaRPr lang="en-US" sz="400" b="1" dirty="0" smtClean="0">
                <a:solidFill>
                  <a:srgbClr val="C00000"/>
                </a:solidFill>
              </a:endParaRP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38</a:t>
              </a:r>
            </a:p>
            <a:p>
              <a:pPr algn="r"/>
              <a:r>
                <a:rPr lang="en-US" sz="1200" b="1" dirty="0" smtClean="0"/>
                <a:t>28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557417" y="1068617"/>
              <a:ext cx="238081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T 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r>
                <a:rPr lang="en-U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.02  0.04  0.06  0.08   0.1 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24531" y="6392402"/>
              <a:ext cx="341825" cy="11003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28</a:t>
              </a: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17</a:t>
              </a:r>
            </a:p>
            <a:p>
              <a:pPr algn="r"/>
              <a:r>
                <a:rPr lang="en-US" sz="1200" b="1" dirty="0" smtClean="0"/>
                <a:t>14</a:t>
              </a:r>
            </a:p>
            <a:p>
              <a:pPr algn="r"/>
              <a:endParaRPr lang="en-US" sz="700" b="1" dirty="0" smtClean="0"/>
            </a:p>
            <a:p>
              <a:pPr algn="r"/>
              <a:r>
                <a:rPr lang="en-US" sz="1200" b="1" dirty="0" smtClean="0"/>
                <a:t>6</a:t>
              </a:r>
            </a:p>
            <a:p>
              <a:pPr algn="r"/>
              <a:r>
                <a:rPr lang="en-US" sz="1200" b="1" dirty="0" smtClean="0"/>
                <a:t>3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519112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3176" y="174629"/>
            <a:ext cx="68057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</a:t>
            </a:r>
            <a:r>
              <a:rPr lang="en-US" sz="1400" b="1" dirty="0" smtClean="0"/>
              <a:t>4B: Raw western blots and their respective images superimposed with membrane.</a:t>
            </a:r>
            <a:endParaRPr lang="en-US" sz="1400" b="1" dirty="0"/>
          </a:p>
        </p:txBody>
      </p:sp>
      <p:grpSp>
        <p:nvGrpSpPr>
          <p:cNvPr id="56" name="Group 55"/>
          <p:cNvGrpSpPr/>
          <p:nvPr/>
        </p:nvGrpSpPr>
        <p:grpSpPr>
          <a:xfrm>
            <a:off x="29109" y="598115"/>
            <a:ext cx="6879862" cy="8989825"/>
            <a:chOff x="29109" y="462651"/>
            <a:chExt cx="6879862" cy="8989825"/>
          </a:xfrm>
        </p:grpSpPr>
        <p:sp>
          <p:nvSpPr>
            <p:cNvPr id="4" name="TextBox 3"/>
            <p:cNvSpPr txBox="1"/>
            <p:nvPr/>
          </p:nvSpPr>
          <p:spPr>
            <a:xfrm>
              <a:off x="6065592" y="5922324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pMLC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080853" y="7083336"/>
              <a:ext cx="75809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MLC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02091" y="8366555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GAPDH</a:t>
              </a:r>
            </a:p>
            <a:p>
              <a:r>
                <a:rPr lang="en-US" sz="1400" b="1" dirty="0" smtClean="0"/>
                <a:t>(37kDa)</a:t>
              </a:r>
              <a:endParaRPr lang="en-US" sz="14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56117" y="9175477"/>
              <a:ext cx="13645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M: Protein Marker</a:t>
              </a:r>
              <a:endParaRPr lang="en-US" sz="1200" b="1" dirty="0"/>
            </a:p>
          </p:txBody>
        </p:sp>
        <p:grpSp>
          <p:nvGrpSpPr>
            <p:cNvPr id="40" name="Group 39"/>
            <p:cNvGrpSpPr/>
            <p:nvPr/>
          </p:nvGrpSpPr>
          <p:grpSpPr>
            <a:xfrm>
              <a:off x="359154" y="778907"/>
              <a:ext cx="5743636" cy="8047593"/>
              <a:chOff x="409953" y="715407"/>
              <a:chExt cx="5947234" cy="8441293"/>
            </a:xfrm>
          </p:grpSpPr>
          <p:cxnSp>
            <p:nvCxnSpPr>
              <p:cNvPr id="11" name="Straight Connector 10"/>
              <p:cNvCxnSpPr/>
              <p:nvPr/>
            </p:nvCxnSpPr>
            <p:spPr>
              <a:xfrm>
                <a:off x="1459790" y="1019290"/>
                <a:ext cx="16459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>
                <a:off x="1819719" y="722748"/>
                <a:ext cx="8447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DJ4 (µM)</a:t>
                </a:r>
                <a:endParaRPr lang="en-US" sz="14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762795" y="1019290"/>
                <a:ext cx="2465205" cy="2421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NT </a:t>
                </a:r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0.15   </a:t>
                </a:r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3 </a:t>
                </a:r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0.6   0.8     1      1.5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32" t="26662" r="9183" b="35201"/>
              <a:stretch/>
            </p:blipFill>
            <p:spPr>
              <a:xfrm>
                <a:off x="489030" y="5020500"/>
                <a:ext cx="2933286" cy="909258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41" t="30646" r="7474" b="23248"/>
              <a:stretch/>
            </p:blipFill>
            <p:spPr>
              <a:xfrm>
                <a:off x="474508" y="7228441"/>
                <a:ext cx="2991371" cy="1099252"/>
              </a:xfrm>
              <a:prstGeom prst="rect">
                <a:avLst/>
              </a:prstGeom>
            </p:spPr>
          </p:pic>
          <p:pic>
            <p:nvPicPr>
              <p:cNvPr id="30" name="Picture 29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14" t="11381" r="8388" b="60728"/>
              <a:stretch/>
            </p:blipFill>
            <p:spPr>
              <a:xfrm>
                <a:off x="467682" y="8388760"/>
                <a:ext cx="2954634" cy="668165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02" t="27221" r="7618" b="35775"/>
              <a:stretch/>
            </p:blipFill>
            <p:spPr>
              <a:xfrm>
                <a:off x="3479097" y="4050605"/>
                <a:ext cx="2820104" cy="873658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02" t="24149" r="9049" b="34180"/>
              <a:stretch/>
            </p:blipFill>
            <p:spPr>
              <a:xfrm>
                <a:off x="3467463" y="4973434"/>
                <a:ext cx="2889724" cy="990684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20" t="17141" b="33259"/>
              <a:stretch/>
            </p:blipFill>
            <p:spPr>
              <a:xfrm flipH="1">
                <a:off x="3422316" y="6025396"/>
                <a:ext cx="2876883" cy="1085329"/>
              </a:xfrm>
              <a:prstGeom prst="rect">
                <a:avLst/>
              </a:prstGeom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37" t="26842" r="6857" b="24098"/>
              <a:stretch/>
            </p:blipFill>
            <p:spPr>
              <a:xfrm>
                <a:off x="3492864" y="7171938"/>
                <a:ext cx="2860680" cy="1107589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68" t="13538" r="9883" b="25793"/>
              <a:stretch/>
            </p:blipFill>
            <p:spPr>
              <a:xfrm>
                <a:off x="3411720" y="8332259"/>
                <a:ext cx="2862080" cy="82444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62" t="21540" r="6072" b="20164"/>
              <a:stretch/>
            </p:blipFill>
            <p:spPr>
              <a:xfrm>
                <a:off x="471652" y="1224866"/>
                <a:ext cx="2802595" cy="1289246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62" r="5943" b="29773"/>
              <a:stretch/>
            </p:blipFill>
            <p:spPr>
              <a:xfrm>
                <a:off x="471652" y="2583243"/>
                <a:ext cx="2979706" cy="1357101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316" r="7931" b="31933"/>
              <a:stretch/>
            </p:blipFill>
            <p:spPr>
              <a:xfrm>
                <a:off x="3451358" y="2567143"/>
                <a:ext cx="2885941" cy="1329355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05" t="19545" r="5729" b="21544"/>
              <a:stretch/>
            </p:blipFill>
            <p:spPr>
              <a:xfrm>
                <a:off x="3451358" y="1211295"/>
                <a:ext cx="2802595" cy="1302817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18" t="16805" b="30342"/>
              <a:stretch/>
            </p:blipFill>
            <p:spPr>
              <a:xfrm flipH="1">
                <a:off x="467682" y="5995725"/>
                <a:ext cx="2983676" cy="1138639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93" t="30311" r="5472" b="34967"/>
              <a:stretch/>
            </p:blipFill>
            <p:spPr>
              <a:xfrm>
                <a:off x="489030" y="4066506"/>
                <a:ext cx="2962329" cy="827832"/>
              </a:xfrm>
              <a:prstGeom prst="rect">
                <a:avLst/>
              </a:prstGeom>
            </p:spPr>
          </p:pic>
          <p:sp>
            <p:nvSpPr>
              <p:cNvPr id="28" name="Rectangle 27"/>
              <p:cNvSpPr/>
              <p:nvPr/>
            </p:nvSpPr>
            <p:spPr>
              <a:xfrm>
                <a:off x="820960" y="722748"/>
                <a:ext cx="2407040" cy="8433952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3748122" y="722748"/>
                <a:ext cx="2407040" cy="8433950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09953" y="895400"/>
                <a:ext cx="442090" cy="3946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M</a:t>
                </a:r>
                <a:endParaRPr lang="en-US" b="1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371434" y="895400"/>
                <a:ext cx="442090" cy="39466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M</a:t>
                </a:r>
                <a:endParaRPr lang="en-US" b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721895" y="993890"/>
                <a:ext cx="2465205" cy="2421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NT </a:t>
                </a:r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r>
                  <a:rPr lang="en-US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0.15   0.3   0.6   0.8     1      1.5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Straight Connector 37"/>
              <p:cNvCxnSpPr/>
              <p:nvPr/>
            </p:nvCxnSpPr>
            <p:spPr>
              <a:xfrm>
                <a:off x="4420782" y="1011949"/>
                <a:ext cx="164592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/>
              <p:cNvSpPr txBox="1"/>
              <p:nvPr/>
            </p:nvSpPr>
            <p:spPr>
              <a:xfrm>
                <a:off x="4780711" y="715407"/>
                <a:ext cx="84478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DJ4 (µM)</a:t>
                </a:r>
                <a:endParaRPr lang="en-US" sz="1400" dirty="0"/>
              </a:p>
            </p:txBody>
          </p:sp>
        </p:grpSp>
        <p:sp>
          <p:nvSpPr>
            <p:cNvPr id="41" name="TextBox 40"/>
            <p:cNvSpPr txBox="1"/>
            <p:nvPr/>
          </p:nvSpPr>
          <p:spPr>
            <a:xfrm>
              <a:off x="6044893" y="5152507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MYPT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40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022257" y="4208717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pMYPT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40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022091" y="2870178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ROCK2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61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001007" y="1475880"/>
              <a:ext cx="84337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ROCK1</a:t>
              </a:r>
            </a:p>
            <a:p>
              <a:r>
                <a:rPr lang="en-US" sz="1400" b="1" dirty="0" smtClean="0"/>
                <a:t>(</a:t>
              </a:r>
              <a:r>
                <a:rPr lang="en-US" sz="1200" b="1" dirty="0" smtClean="0"/>
                <a:t>158kDa</a:t>
              </a:r>
              <a:r>
                <a:rPr lang="en-US" sz="1400" b="1" dirty="0" smtClean="0"/>
                <a:t>)</a:t>
              </a:r>
              <a:endParaRPr lang="en-US" sz="1400" b="1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404381" y="462651"/>
              <a:ext cx="11737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Actual Blots</a:t>
              </a:r>
              <a:endParaRPr lang="en-US" sz="16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3218" y="498173"/>
              <a:ext cx="28500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Blots-superimposed with membrane</a:t>
              </a:r>
              <a:endParaRPr lang="en-US" sz="1400" dirty="0"/>
            </a:p>
          </p:txBody>
        </p:sp>
        <p:sp>
          <p:nvSpPr>
            <p:cNvPr id="47" name="Right Arrow 46"/>
            <p:cNvSpPr/>
            <p:nvPr/>
          </p:nvSpPr>
          <p:spPr>
            <a:xfrm>
              <a:off x="3436766" y="585329"/>
              <a:ext cx="619425" cy="12397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109" y="1029292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/>
                <a:t>kDa</a:t>
              </a:r>
              <a:endParaRPr lang="en-US" sz="1200" b="1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7999" y="1334866"/>
              <a:ext cx="420371" cy="12618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endParaRPr lang="en-US" sz="700" b="1" dirty="0"/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1400" b="1" dirty="0"/>
            </a:p>
            <a:p>
              <a:pPr algn="r"/>
              <a:r>
                <a:rPr lang="en-US" sz="1200" b="1" dirty="0" smtClean="0"/>
                <a:t>62</a:t>
              </a:r>
            </a:p>
            <a:p>
              <a:pPr algn="r"/>
              <a:endParaRPr lang="en-US" sz="700" b="1" dirty="0"/>
            </a:p>
            <a:p>
              <a:pPr algn="r"/>
              <a:r>
                <a:rPr lang="en-US" sz="1200" b="1" dirty="0" smtClean="0"/>
                <a:t>49</a:t>
              </a:r>
              <a:endParaRPr lang="en-US" sz="1200" b="1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7999" y="2792191"/>
              <a:ext cx="420371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endParaRPr lang="en-US" sz="600" b="1" dirty="0"/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1200" b="1" dirty="0"/>
            </a:p>
            <a:p>
              <a:pPr algn="r"/>
              <a:r>
                <a:rPr lang="en-US" sz="1200" b="1" dirty="0" smtClean="0"/>
                <a:t>62</a:t>
              </a:r>
            </a:p>
            <a:p>
              <a:pPr algn="r"/>
              <a:endParaRPr lang="en-US" sz="600" b="1" dirty="0"/>
            </a:p>
            <a:p>
              <a:pPr algn="r"/>
              <a:r>
                <a:rPr lang="en-US" sz="1200" b="1" dirty="0" smtClean="0"/>
                <a:t>49</a:t>
              </a:r>
              <a:endParaRPr lang="en-US" sz="1200" b="1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90699" y="4081241"/>
              <a:ext cx="420371" cy="723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400" b="1" dirty="0" smtClean="0"/>
            </a:p>
            <a:p>
              <a:pPr algn="r"/>
              <a:r>
                <a:rPr lang="en-US" sz="1200" b="1" dirty="0" smtClean="0"/>
                <a:t>62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97049" y="5071841"/>
              <a:ext cx="420371" cy="7232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dirty="0" smtClean="0"/>
                <a:t>198</a:t>
              </a:r>
            </a:p>
            <a:p>
              <a:pPr algn="r"/>
              <a:r>
                <a:rPr lang="en-US" sz="1200" b="1" dirty="0" smtClean="0"/>
                <a:t>98</a:t>
              </a:r>
            </a:p>
            <a:p>
              <a:pPr algn="r"/>
              <a:endParaRPr lang="en-US" sz="400" b="1" dirty="0" smtClean="0"/>
            </a:p>
            <a:p>
              <a:pPr algn="r"/>
              <a:r>
                <a:rPr lang="en-US" sz="1200" b="1" dirty="0" smtClean="0"/>
                <a:t>62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56545" y="5751291"/>
              <a:ext cx="341825" cy="9156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28</a:t>
              </a: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17</a:t>
              </a:r>
            </a:p>
            <a:p>
              <a:pPr algn="r"/>
              <a:r>
                <a:rPr lang="en-US" sz="1200" b="1" dirty="0" smtClean="0"/>
                <a:t>14</a:t>
              </a:r>
            </a:p>
            <a:p>
              <a:pPr algn="r"/>
              <a:endParaRPr lang="en-US" sz="700" b="1" dirty="0" smtClean="0"/>
            </a:p>
            <a:p>
              <a:pPr algn="r"/>
              <a:r>
                <a:rPr lang="en-US" sz="1200" b="1" dirty="0" smtClean="0"/>
                <a:t>6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24531" y="6959670"/>
              <a:ext cx="341825" cy="1177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28</a:t>
              </a: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17</a:t>
              </a:r>
            </a:p>
            <a:p>
              <a:pPr algn="r"/>
              <a:r>
                <a:rPr lang="en-US" sz="1200" b="1" dirty="0" smtClean="0"/>
                <a:t>14</a:t>
              </a:r>
            </a:p>
            <a:p>
              <a:pPr algn="r"/>
              <a:endParaRPr lang="en-US" sz="700" b="1" dirty="0" smtClean="0"/>
            </a:p>
            <a:p>
              <a:pPr algn="r"/>
              <a:r>
                <a:rPr lang="en-US" sz="1200" b="1" dirty="0" smtClean="0"/>
                <a:t>6</a:t>
              </a:r>
            </a:p>
            <a:p>
              <a:pPr algn="r"/>
              <a:endParaRPr lang="en-US" sz="400" b="1" dirty="0" smtClean="0"/>
            </a:p>
            <a:p>
              <a:pPr algn="r"/>
              <a:r>
                <a:rPr lang="en-US" sz="1200" b="1" dirty="0"/>
                <a:t>3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43845" y="8113491"/>
              <a:ext cx="341825" cy="6848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/>
                <a:t>49</a:t>
              </a:r>
            </a:p>
            <a:p>
              <a:pPr algn="r"/>
              <a:endParaRPr lang="en-US" sz="400" b="1" dirty="0" smtClean="0">
                <a:solidFill>
                  <a:srgbClr val="C00000"/>
                </a:solidFill>
              </a:endParaRPr>
            </a:p>
            <a:p>
              <a:pPr algn="r"/>
              <a:r>
                <a:rPr lang="en-US" sz="1200" b="1" dirty="0" smtClean="0">
                  <a:solidFill>
                    <a:srgbClr val="C00000"/>
                  </a:solidFill>
                </a:rPr>
                <a:t>38</a:t>
              </a:r>
            </a:p>
            <a:p>
              <a:pPr algn="r"/>
              <a:r>
                <a:rPr lang="en-US" sz="1200" b="1" dirty="0" smtClean="0"/>
                <a:t>2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34278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</TotalTime>
  <Words>207</Words>
  <Application>Microsoft Office PowerPoint</Application>
  <PresentationFormat>A4 Paper (210x297 mm)</PresentationFormat>
  <Paragraphs>1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lla, Upendar Rao</dc:creator>
  <cp:lastModifiedBy>Golla, Upendar Rao</cp:lastModifiedBy>
  <cp:revision>24</cp:revision>
  <dcterms:created xsi:type="dcterms:W3CDTF">2021-08-11T22:19:49Z</dcterms:created>
  <dcterms:modified xsi:type="dcterms:W3CDTF">2021-09-10T21:13:28Z</dcterms:modified>
</cp:coreProperties>
</file>